
<file path=[Content_Types].xml><?xml version="1.0" encoding="utf-8"?>
<Types xmlns="http://schemas.openxmlformats.org/package/2006/content-types">
  <Default Extension="gif" ContentType="image/gif"/>
  <Default Extension="jfif" ContentType="image/jpeg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2" r:id="rId6"/>
    <p:sldId id="261" r:id="rId7"/>
    <p:sldId id="263" r:id="rId8"/>
    <p:sldId id="264" r:id="rId9"/>
    <p:sldId id="265" r:id="rId10"/>
    <p:sldId id="266" r:id="rId11"/>
    <p:sldId id="26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20B7CE2-1B4B-4EE1-A29B-6993B25FBB59}" type="doc">
      <dgm:prSet loTypeId="urn:microsoft.com/office/officeart/2005/8/layout/cycle2" loCatId="cycle" qsTypeId="urn:microsoft.com/office/officeart/2005/8/quickstyle/simple1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E898FDC8-0FC6-4ACF-96AD-8B64BE2F3826}">
      <dgm:prSet phldrT="[Text]"/>
      <dgm:spPr>
        <a:xfrm>
          <a:off x="4600575" y="231"/>
          <a:ext cx="1314449" cy="1314449"/>
        </a:xfrm>
        <a:prstGeom prst="ellipse">
          <a:avLst/>
        </a:prstGeom>
        <a:solidFill>
          <a:srgbClr val="ED7D31">
            <a:hueOff val="0"/>
            <a:satOff val="0"/>
            <a:lumOff val="0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r>
            <a:rPr lang="ar-SY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السؤال</a:t>
          </a:r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64BA021B-A233-4EBF-AE5A-C501249AEDDE}" type="parTrans" cxnId="{21A328C3-9C5C-4A66-89A5-0891DC5DEF4B}">
      <dgm:prSet/>
      <dgm:spPr/>
      <dgm:t>
        <a:bodyPr/>
        <a:lstStyle/>
        <a:p>
          <a:endParaRPr lang="en-US"/>
        </a:p>
      </dgm:t>
    </dgm:pt>
    <dgm:pt modelId="{2FA8F796-D3F9-4E9F-9FAF-6C63AF44D8B1}" type="sibTrans" cxnId="{21A328C3-9C5C-4A66-89A5-0891DC5DEF4B}">
      <dgm:prSet/>
      <dgm:spPr>
        <a:xfrm rot="2160000">
          <a:off x="5873411" y="1009740"/>
          <a:ext cx="349131" cy="443626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0"/>
            <a:satOff val="0"/>
            <a:lumOff val="0"/>
            <a:alphaOff val="0"/>
          </a:srgbClr>
        </a:solidFill>
        <a:ln>
          <a:noFill/>
        </a:ln>
        <a:effectLst/>
      </dgm:spPr>
      <dgm:t>
        <a:bodyPr/>
        <a:lstStyle/>
        <a:p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DBBA55CF-7EDF-4CEA-AF48-B2E90917E7AA}">
      <dgm:prSet phldrT="[Text]"/>
      <dgm:spPr>
        <a:xfrm>
          <a:off x="6196918" y="1160042"/>
          <a:ext cx="1314449" cy="1314449"/>
        </a:xfrm>
        <a:prstGeom prst="ellipse">
          <a:avLst/>
        </a:prstGeom>
        <a:solidFill>
          <a:srgbClr val="ED7D31">
            <a:hueOff val="-363841"/>
            <a:satOff val="-20982"/>
            <a:lumOff val="2157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r>
            <a:rPr lang="ar-SY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البحث</a:t>
          </a:r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0C05F400-9AEF-434F-A433-224AAC8C11AF}" type="parTrans" cxnId="{5AC34465-CDD9-4EBB-9D4B-DC5F62A168FA}">
      <dgm:prSet/>
      <dgm:spPr/>
      <dgm:t>
        <a:bodyPr/>
        <a:lstStyle/>
        <a:p>
          <a:endParaRPr lang="en-US"/>
        </a:p>
      </dgm:t>
    </dgm:pt>
    <dgm:pt modelId="{4AEECA14-EC53-4CEF-B0CE-5E5532B3B657}" type="sibTrans" cxnId="{5AC34465-CDD9-4EBB-9D4B-DC5F62A168FA}">
      <dgm:prSet/>
      <dgm:spPr>
        <a:xfrm rot="6480000">
          <a:off x="6377756" y="2524363"/>
          <a:ext cx="349131" cy="443626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-363841"/>
            <a:satOff val="-20982"/>
            <a:lumOff val="2157"/>
            <a:alphaOff val="0"/>
          </a:srgbClr>
        </a:solidFill>
        <a:ln>
          <a:noFill/>
        </a:ln>
        <a:effectLst/>
      </dgm:spPr>
      <dgm:t>
        <a:bodyPr/>
        <a:lstStyle/>
        <a:p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8EB2417E-8A96-405C-A029-297F03AE8CA4}">
      <dgm:prSet phldrT="[Text]"/>
      <dgm:spPr>
        <a:xfrm>
          <a:off x="5587169" y="3036656"/>
          <a:ext cx="1314449" cy="1314449"/>
        </a:xfrm>
        <a:prstGeom prst="ellipse">
          <a:avLst/>
        </a:prstGeom>
        <a:solidFill>
          <a:srgbClr val="ED7D31">
            <a:hueOff val="-727682"/>
            <a:satOff val="-41964"/>
            <a:lumOff val="4314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r>
            <a:rPr lang="ar-SY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التقييم النقدي</a:t>
          </a:r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973D9354-8910-4CAA-8BEE-68AEF74371AF}" type="parTrans" cxnId="{B6CDDCEA-A152-4DE1-B6FB-6F266BD48DCB}">
      <dgm:prSet/>
      <dgm:spPr/>
      <dgm:t>
        <a:bodyPr/>
        <a:lstStyle/>
        <a:p>
          <a:endParaRPr lang="en-US"/>
        </a:p>
      </dgm:t>
    </dgm:pt>
    <dgm:pt modelId="{C869F0D2-9624-42C2-A885-EF57CC15D839}" type="sibTrans" cxnId="{B6CDDCEA-A152-4DE1-B6FB-6F266BD48DCB}">
      <dgm:prSet/>
      <dgm:spPr>
        <a:xfrm rot="10800000">
          <a:off x="5093115" y="3472068"/>
          <a:ext cx="349131" cy="443626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-727682"/>
            <a:satOff val="-41964"/>
            <a:lumOff val="4314"/>
            <a:alphaOff val="0"/>
          </a:srgbClr>
        </a:solidFill>
        <a:ln>
          <a:noFill/>
        </a:ln>
        <a:effectLst/>
      </dgm:spPr>
      <dgm:t>
        <a:bodyPr/>
        <a:lstStyle/>
        <a:p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41E82A5E-A598-4C42-B425-B24C25FCEC91}">
      <dgm:prSet phldrT="[Text]"/>
      <dgm:spPr>
        <a:xfrm>
          <a:off x="3613980" y="3036656"/>
          <a:ext cx="1314449" cy="1314449"/>
        </a:xfrm>
        <a:prstGeom prst="ellipse">
          <a:avLst/>
        </a:prstGeom>
        <a:solidFill>
          <a:srgbClr val="ED7D31">
            <a:hueOff val="-1091522"/>
            <a:satOff val="-62946"/>
            <a:lumOff val="6471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r>
            <a:rPr lang="ar-SY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التطبيق</a:t>
          </a:r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B1A1CF89-4AE7-40FC-9BE0-7E9B443264BD}" type="parTrans" cxnId="{EAE2B13C-BED4-4755-9092-4E962611A913}">
      <dgm:prSet/>
      <dgm:spPr/>
      <dgm:t>
        <a:bodyPr/>
        <a:lstStyle/>
        <a:p>
          <a:endParaRPr lang="en-US"/>
        </a:p>
      </dgm:t>
    </dgm:pt>
    <dgm:pt modelId="{7D70E607-8ADC-47E9-A05B-64BD2D7A993D}" type="sibTrans" cxnId="{EAE2B13C-BED4-4755-9092-4E962611A913}">
      <dgm:prSet/>
      <dgm:spPr>
        <a:xfrm rot="15120000">
          <a:off x="3794818" y="2543158"/>
          <a:ext cx="349131" cy="443626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-1091522"/>
            <a:satOff val="-62946"/>
            <a:lumOff val="6471"/>
            <a:alphaOff val="0"/>
          </a:srgbClr>
        </a:solidFill>
        <a:ln>
          <a:noFill/>
        </a:ln>
        <a:effectLst/>
      </dgm:spPr>
      <dgm:t>
        <a:bodyPr/>
        <a:lstStyle/>
        <a:p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CF99C8D3-4206-45A0-8507-BE0F38FB7B52}">
      <dgm:prSet phldrT="[Text]"/>
      <dgm:spPr>
        <a:xfrm>
          <a:off x="3004231" y="1160042"/>
          <a:ext cx="1314449" cy="1314449"/>
        </a:xfrm>
        <a:prstGeom prst="ellipse">
          <a:avLst/>
        </a:prstGeom>
        <a:solidFill>
          <a:srgbClr val="ED7D31">
            <a:hueOff val="-1455363"/>
            <a:satOff val="-83928"/>
            <a:lumOff val="8628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r>
            <a:rPr lang="ar-SY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تقويم الأداء</a:t>
          </a:r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CF8780C6-E574-4FB0-8DCB-9F6C413A6CB1}" type="parTrans" cxnId="{7DB8A444-0653-4E56-B522-17570671285D}">
      <dgm:prSet/>
      <dgm:spPr/>
      <dgm:t>
        <a:bodyPr/>
        <a:lstStyle/>
        <a:p>
          <a:endParaRPr lang="en-US"/>
        </a:p>
      </dgm:t>
    </dgm:pt>
    <dgm:pt modelId="{725B5371-81DF-490F-AA1F-E1E7B8DF49CC}" type="sibTrans" cxnId="{7DB8A444-0653-4E56-B522-17570671285D}">
      <dgm:prSet/>
      <dgm:spPr>
        <a:xfrm rot="19440000">
          <a:off x="4277068" y="1021356"/>
          <a:ext cx="349131" cy="443626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-1455363"/>
            <a:satOff val="-83928"/>
            <a:lumOff val="8628"/>
            <a:alphaOff val="0"/>
          </a:srgbClr>
        </a:solidFill>
        <a:ln>
          <a:noFill/>
        </a:ln>
        <a:effectLst/>
      </dgm:spPr>
      <dgm:t>
        <a:bodyPr/>
        <a:lstStyle/>
        <a:p>
          <a:endParaRPr lang="en-US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1B0604F9-4BC8-4467-B736-9599BBB1A4D9}" type="pres">
      <dgm:prSet presAssocID="{820B7CE2-1B4B-4EE1-A29B-6993B25FBB59}" presName="cycle" presStyleCnt="0">
        <dgm:presLayoutVars>
          <dgm:dir/>
          <dgm:resizeHandles val="exact"/>
        </dgm:presLayoutVars>
      </dgm:prSet>
      <dgm:spPr/>
    </dgm:pt>
    <dgm:pt modelId="{5A1375D1-5864-4AC9-84ED-00E969387C1B}" type="pres">
      <dgm:prSet presAssocID="{E898FDC8-0FC6-4ACF-96AD-8B64BE2F3826}" presName="node" presStyleLbl="node1" presStyleIdx="0" presStyleCnt="5">
        <dgm:presLayoutVars>
          <dgm:bulletEnabled val="1"/>
        </dgm:presLayoutVars>
      </dgm:prSet>
      <dgm:spPr/>
    </dgm:pt>
    <dgm:pt modelId="{B5B9E9E2-DEF1-4B04-8386-DDBBD3119DF4}" type="pres">
      <dgm:prSet presAssocID="{2FA8F796-D3F9-4E9F-9FAF-6C63AF44D8B1}" presName="sibTrans" presStyleLbl="sibTrans2D1" presStyleIdx="0" presStyleCnt="5"/>
      <dgm:spPr/>
    </dgm:pt>
    <dgm:pt modelId="{FBB17252-C696-4565-AB74-2CD9A6216F9E}" type="pres">
      <dgm:prSet presAssocID="{2FA8F796-D3F9-4E9F-9FAF-6C63AF44D8B1}" presName="connectorText" presStyleLbl="sibTrans2D1" presStyleIdx="0" presStyleCnt="5"/>
      <dgm:spPr/>
    </dgm:pt>
    <dgm:pt modelId="{B28996AE-1330-4ADC-AAB5-364032624F7E}" type="pres">
      <dgm:prSet presAssocID="{DBBA55CF-7EDF-4CEA-AF48-B2E90917E7AA}" presName="node" presStyleLbl="node1" presStyleIdx="1" presStyleCnt="5">
        <dgm:presLayoutVars>
          <dgm:bulletEnabled val="1"/>
        </dgm:presLayoutVars>
      </dgm:prSet>
      <dgm:spPr/>
    </dgm:pt>
    <dgm:pt modelId="{BA9DA9AF-FAC5-4FFA-98AD-952493E9C966}" type="pres">
      <dgm:prSet presAssocID="{4AEECA14-EC53-4CEF-B0CE-5E5532B3B657}" presName="sibTrans" presStyleLbl="sibTrans2D1" presStyleIdx="1" presStyleCnt="5"/>
      <dgm:spPr/>
    </dgm:pt>
    <dgm:pt modelId="{3D4023AB-CE9C-4498-A2D5-CF728BC8B4CA}" type="pres">
      <dgm:prSet presAssocID="{4AEECA14-EC53-4CEF-B0CE-5E5532B3B657}" presName="connectorText" presStyleLbl="sibTrans2D1" presStyleIdx="1" presStyleCnt="5"/>
      <dgm:spPr/>
    </dgm:pt>
    <dgm:pt modelId="{16313D95-D8F8-4FF6-91AE-12BC24626682}" type="pres">
      <dgm:prSet presAssocID="{8EB2417E-8A96-405C-A029-297F03AE8CA4}" presName="node" presStyleLbl="node1" presStyleIdx="2" presStyleCnt="5">
        <dgm:presLayoutVars>
          <dgm:bulletEnabled val="1"/>
        </dgm:presLayoutVars>
      </dgm:prSet>
      <dgm:spPr/>
    </dgm:pt>
    <dgm:pt modelId="{84DAFBFF-2251-47BC-B1CF-B067C2CA39A2}" type="pres">
      <dgm:prSet presAssocID="{C869F0D2-9624-42C2-A885-EF57CC15D839}" presName="sibTrans" presStyleLbl="sibTrans2D1" presStyleIdx="2" presStyleCnt="5"/>
      <dgm:spPr/>
    </dgm:pt>
    <dgm:pt modelId="{0B7CD69B-9973-48E2-828B-D4445C73A945}" type="pres">
      <dgm:prSet presAssocID="{C869F0D2-9624-42C2-A885-EF57CC15D839}" presName="connectorText" presStyleLbl="sibTrans2D1" presStyleIdx="2" presStyleCnt="5"/>
      <dgm:spPr/>
    </dgm:pt>
    <dgm:pt modelId="{E7FC3841-A06C-4102-81B4-B7FBBDC76C0B}" type="pres">
      <dgm:prSet presAssocID="{41E82A5E-A598-4C42-B425-B24C25FCEC91}" presName="node" presStyleLbl="node1" presStyleIdx="3" presStyleCnt="5">
        <dgm:presLayoutVars>
          <dgm:bulletEnabled val="1"/>
        </dgm:presLayoutVars>
      </dgm:prSet>
      <dgm:spPr/>
    </dgm:pt>
    <dgm:pt modelId="{90241673-4260-465D-8026-A437EDF5BB01}" type="pres">
      <dgm:prSet presAssocID="{7D70E607-8ADC-47E9-A05B-64BD2D7A993D}" presName="sibTrans" presStyleLbl="sibTrans2D1" presStyleIdx="3" presStyleCnt="5"/>
      <dgm:spPr/>
    </dgm:pt>
    <dgm:pt modelId="{ED8B5CC7-98F0-4C74-B4F2-E1B662B3DBDF}" type="pres">
      <dgm:prSet presAssocID="{7D70E607-8ADC-47E9-A05B-64BD2D7A993D}" presName="connectorText" presStyleLbl="sibTrans2D1" presStyleIdx="3" presStyleCnt="5"/>
      <dgm:spPr/>
    </dgm:pt>
    <dgm:pt modelId="{1B335BBB-EE84-4959-B622-268317A8EE60}" type="pres">
      <dgm:prSet presAssocID="{CF99C8D3-4206-45A0-8507-BE0F38FB7B52}" presName="node" presStyleLbl="node1" presStyleIdx="4" presStyleCnt="5">
        <dgm:presLayoutVars>
          <dgm:bulletEnabled val="1"/>
        </dgm:presLayoutVars>
      </dgm:prSet>
      <dgm:spPr/>
    </dgm:pt>
    <dgm:pt modelId="{6FC30703-DC2D-4B84-8C6B-174B073A088A}" type="pres">
      <dgm:prSet presAssocID="{725B5371-81DF-490F-AA1F-E1E7B8DF49CC}" presName="sibTrans" presStyleLbl="sibTrans2D1" presStyleIdx="4" presStyleCnt="5"/>
      <dgm:spPr/>
    </dgm:pt>
    <dgm:pt modelId="{A0C89C7F-D1C5-43D4-8C60-151B53E3FFB3}" type="pres">
      <dgm:prSet presAssocID="{725B5371-81DF-490F-AA1F-E1E7B8DF49CC}" presName="connectorText" presStyleLbl="sibTrans2D1" presStyleIdx="4" presStyleCnt="5"/>
      <dgm:spPr/>
    </dgm:pt>
  </dgm:ptLst>
  <dgm:cxnLst>
    <dgm:cxn modelId="{2782FD0C-F43B-43A4-ACD2-D58C9B5EF6D0}" type="presOf" srcId="{C869F0D2-9624-42C2-A885-EF57CC15D839}" destId="{0B7CD69B-9973-48E2-828B-D4445C73A945}" srcOrd="1" destOrd="0" presId="urn:microsoft.com/office/officeart/2005/8/layout/cycle2"/>
    <dgm:cxn modelId="{C76B6218-9D10-4781-9B5C-7A9090A2332A}" type="presOf" srcId="{41E82A5E-A598-4C42-B425-B24C25FCEC91}" destId="{E7FC3841-A06C-4102-81B4-B7FBBDC76C0B}" srcOrd="0" destOrd="0" presId="urn:microsoft.com/office/officeart/2005/8/layout/cycle2"/>
    <dgm:cxn modelId="{3910A51A-0095-4120-B391-9582780F81AC}" type="presOf" srcId="{4AEECA14-EC53-4CEF-B0CE-5E5532B3B657}" destId="{3D4023AB-CE9C-4498-A2D5-CF728BC8B4CA}" srcOrd="1" destOrd="0" presId="urn:microsoft.com/office/officeart/2005/8/layout/cycle2"/>
    <dgm:cxn modelId="{3460F71E-A461-4176-A9EC-09884CACD72A}" type="presOf" srcId="{DBBA55CF-7EDF-4CEA-AF48-B2E90917E7AA}" destId="{B28996AE-1330-4ADC-AAB5-364032624F7E}" srcOrd="0" destOrd="0" presId="urn:microsoft.com/office/officeart/2005/8/layout/cycle2"/>
    <dgm:cxn modelId="{8F7FFC20-ED80-43C1-BDA4-61B30C532C20}" type="presOf" srcId="{7D70E607-8ADC-47E9-A05B-64BD2D7A993D}" destId="{ED8B5CC7-98F0-4C74-B4F2-E1B662B3DBDF}" srcOrd="1" destOrd="0" presId="urn:microsoft.com/office/officeart/2005/8/layout/cycle2"/>
    <dgm:cxn modelId="{D3AF1B22-E50E-4490-9102-FB26A8F48917}" type="presOf" srcId="{820B7CE2-1B4B-4EE1-A29B-6993B25FBB59}" destId="{1B0604F9-4BC8-4467-B736-9599BBB1A4D9}" srcOrd="0" destOrd="0" presId="urn:microsoft.com/office/officeart/2005/8/layout/cycle2"/>
    <dgm:cxn modelId="{2D482A28-5A90-4A4E-9225-34EC987AC611}" type="presOf" srcId="{4AEECA14-EC53-4CEF-B0CE-5E5532B3B657}" destId="{BA9DA9AF-FAC5-4FFA-98AD-952493E9C966}" srcOrd="0" destOrd="0" presId="urn:microsoft.com/office/officeart/2005/8/layout/cycle2"/>
    <dgm:cxn modelId="{C01ED628-1CBD-451A-BA96-4189FC136D78}" type="presOf" srcId="{E898FDC8-0FC6-4ACF-96AD-8B64BE2F3826}" destId="{5A1375D1-5864-4AC9-84ED-00E969387C1B}" srcOrd="0" destOrd="0" presId="urn:microsoft.com/office/officeart/2005/8/layout/cycle2"/>
    <dgm:cxn modelId="{EAE2B13C-BED4-4755-9092-4E962611A913}" srcId="{820B7CE2-1B4B-4EE1-A29B-6993B25FBB59}" destId="{41E82A5E-A598-4C42-B425-B24C25FCEC91}" srcOrd="3" destOrd="0" parTransId="{B1A1CF89-4AE7-40FC-9BE0-7E9B443264BD}" sibTransId="{7D70E607-8ADC-47E9-A05B-64BD2D7A993D}"/>
    <dgm:cxn modelId="{7DB8A444-0653-4E56-B522-17570671285D}" srcId="{820B7CE2-1B4B-4EE1-A29B-6993B25FBB59}" destId="{CF99C8D3-4206-45A0-8507-BE0F38FB7B52}" srcOrd="4" destOrd="0" parTransId="{CF8780C6-E574-4FB0-8DCB-9F6C413A6CB1}" sibTransId="{725B5371-81DF-490F-AA1F-E1E7B8DF49CC}"/>
    <dgm:cxn modelId="{5AC34465-CDD9-4EBB-9D4B-DC5F62A168FA}" srcId="{820B7CE2-1B4B-4EE1-A29B-6993B25FBB59}" destId="{DBBA55CF-7EDF-4CEA-AF48-B2E90917E7AA}" srcOrd="1" destOrd="0" parTransId="{0C05F400-9AEF-434F-A433-224AAC8C11AF}" sibTransId="{4AEECA14-EC53-4CEF-B0CE-5E5532B3B657}"/>
    <dgm:cxn modelId="{1D998749-F8F1-42E3-9253-D38E56D89927}" type="presOf" srcId="{C869F0D2-9624-42C2-A885-EF57CC15D839}" destId="{84DAFBFF-2251-47BC-B1CF-B067C2CA39A2}" srcOrd="0" destOrd="0" presId="urn:microsoft.com/office/officeart/2005/8/layout/cycle2"/>
    <dgm:cxn modelId="{CA15316D-8A5C-426E-B4B9-A501AB480311}" type="presOf" srcId="{2FA8F796-D3F9-4E9F-9FAF-6C63AF44D8B1}" destId="{B5B9E9E2-DEF1-4B04-8386-DDBBD3119DF4}" srcOrd="0" destOrd="0" presId="urn:microsoft.com/office/officeart/2005/8/layout/cycle2"/>
    <dgm:cxn modelId="{9909258F-4880-4603-99C5-CD7618F59AE7}" type="presOf" srcId="{725B5371-81DF-490F-AA1F-E1E7B8DF49CC}" destId="{6FC30703-DC2D-4B84-8C6B-174B073A088A}" srcOrd="0" destOrd="0" presId="urn:microsoft.com/office/officeart/2005/8/layout/cycle2"/>
    <dgm:cxn modelId="{E40BC594-CFB0-444E-9C17-0B3B3E5AA5E3}" type="presOf" srcId="{8EB2417E-8A96-405C-A029-297F03AE8CA4}" destId="{16313D95-D8F8-4FF6-91AE-12BC24626682}" srcOrd="0" destOrd="0" presId="urn:microsoft.com/office/officeart/2005/8/layout/cycle2"/>
    <dgm:cxn modelId="{68DFFEA2-BCA8-4E47-BAC8-6E4270D1ADA4}" type="presOf" srcId="{CF99C8D3-4206-45A0-8507-BE0F38FB7B52}" destId="{1B335BBB-EE84-4959-B622-268317A8EE60}" srcOrd="0" destOrd="0" presId="urn:microsoft.com/office/officeart/2005/8/layout/cycle2"/>
    <dgm:cxn modelId="{E8B389B9-FB56-4503-884D-5A963747F0A7}" type="presOf" srcId="{7D70E607-8ADC-47E9-A05B-64BD2D7A993D}" destId="{90241673-4260-465D-8026-A437EDF5BB01}" srcOrd="0" destOrd="0" presId="urn:microsoft.com/office/officeart/2005/8/layout/cycle2"/>
    <dgm:cxn modelId="{21A328C3-9C5C-4A66-89A5-0891DC5DEF4B}" srcId="{820B7CE2-1B4B-4EE1-A29B-6993B25FBB59}" destId="{E898FDC8-0FC6-4ACF-96AD-8B64BE2F3826}" srcOrd="0" destOrd="0" parTransId="{64BA021B-A233-4EBF-AE5A-C501249AEDDE}" sibTransId="{2FA8F796-D3F9-4E9F-9FAF-6C63AF44D8B1}"/>
    <dgm:cxn modelId="{B6CDDCEA-A152-4DE1-B6FB-6F266BD48DCB}" srcId="{820B7CE2-1B4B-4EE1-A29B-6993B25FBB59}" destId="{8EB2417E-8A96-405C-A029-297F03AE8CA4}" srcOrd="2" destOrd="0" parTransId="{973D9354-8910-4CAA-8BEE-68AEF74371AF}" sibTransId="{C869F0D2-9624-42C2-A885-EF57CC15D839}"/>
    <dgm:cxn modelId="{C2FD31F6-4D4A-49A3-80A5-566227B14424}" type="presOf" srcId="{2FA8F796-D3F9-4E9F-9FAF-6C63AF44D8B1}" destId="{FBB17252-C696-4565-AB74-2CD9A6216F9E}" srcOrd="1" destOrd="0" presId="urn:microsoft.com/office/officeart/2005/8/layout/cycle2"/>
    <dgm:cxn modelId="{579F3AFD-F868-4F9D-BA20-81F152FE0CF5}" type="presOf" srcId="{725B5371-81DF-490F-AA1F-E1E7B8DF49CC}" destId="{A0C89C7F-D1C5-43D4-8C60-151B53E3FFB3}" srcOrd="1" destOrd="0" presId="urn:microsoft.com/office/officeart/2005/8/layout/cycle2"/>
    <dgm:cxn modelId="{E0A85B38-3D2D-4527-BAE3-88227DD6B0CC}" type="presParOf" srcId="{1B0604F9-4BC8-4467-B736-9599BBB1A4D9}" destId="{5A1375D1-5864-4AC9-84ED-00E969387C1B}" srcOrd="0" destOrd="0" presId="urn:microsoft.com/office/officeart/2005/8/layout/cycle2"/>
    <dgm:cxn modelId="{4CF1C69E-28E7-4309-8974-8ECB9E8B9FB4}" type="presParOf" srcId="{1B0604F9-4BC8-4467-B736-9599BBB1A4D9}" destId="{B5B9E9E2-DEF1-4B04-8386-DDBBD3119DF4}" srcOrd="1" destOrd="0" presId="urn:microsoft.com/office/officeart/2005/8/layout/cycle2"/>
    <dgm:cxn modelId="{ABF0AB00-7317-41F8-BF59-3288DCBA1D8A}" type="presParOf" srcId="{B5B9E9E2-DEF1-4B04-8386-DDBBD3119DF4}" destId="{FBB17252-C696-4565-AB74-2CD9A6216F9E}" srcOrd="0" destOrd="0" presId="urn:microsoft.com/office/officeart/2005/8/layout/cycle2"/>
    <dgm:cxn modelId="{CB377E9F-4453-4D8B-A827-0DE794587BF3}" type="presParOf" srcId="{1B0604F9-4BC8-4467-B736-9599BBB1A4D9}" destId="{B28996AE-1330-4ADC-AAB5-364032624F7E}" srcOrd="2" destOrd="0" presId="urn:microsoft.com/office/officeart/2005/8/layout/cycle2"/>
    <dgm:cxn modelId="{147A283C-99A5-45FD-B922-048297AAFC06}" type="presParOf" srcId="{1B0604F9-4BC8-4467-B736-9599BBB1A4D9}" destId="{BA9DA9AF-FAC5-4FFA-98AD-952493E9C966}" srcOrd="3" destOrd="0" presId="urn:microsoft.com/office/officeart/2005/8/layout/cycle2"/>
    <dgm:cxn modelId="{DD753A98-5B9F-498E-8128-E1C4C0D0BC95}" type="presParOf" srcId="{BA9DA9AF-FAC5-4FFA-98AD-952493E9C966}" destId="{3D4023AB-CE9C-4498-A2D5-CF728BC8B4CA}" srcOrd="0" destOrd="0" presId="urn:microsoft.com/office/officeart/2005/8/layout/cycle2"/>
    <dgm:cxn modelId="{40375B0D-1F6D-4FD4-BDAE-9D124AE972C9}" type="presParOf" srcId="{1B0604F9-4BC8-4467-B736-9599BBB1A4D9}" destId="{16313D95-D8F8-4FF6-91AE-12BC24626682}" srcOrd="4" destOrd="0" presId="urn:microsoft.com/office/officeart/2005/8/layout/cycle2"/>
    <dgm:cxn modelId="{4F71CC93-80AD-4AD4-A6C4-5E778F0A5BED}" type="presParOf" srcId="{1B0604F9-4BC8-4467-B736-9599BBB1A4D9}" destId="{84DAFBFF-2251-47BC-B1CF-B067C2CA39A2}" srcOrd="5" destOrd="0" presId="urn:microsoft.com/office/officeart/2005/8/layout/cycle2"/>
    <dgm:cxn modelId="{F4CA3C8D-AFDB-431A-A0A4-95822FE9A6C6}" type="presParOf" srcId="{84DAFBFF-2251-47BC-B1CF-B067C2CA39A2}" destId="{0B7CD69B-9973-48E2-828B-D4445C73A945}" srcOrd="0" destOrd="0" presId="urn:microsoft.com/office/officeart/2005/8/layout/cycle2"/>
    <dgm:cxn modelId="{083FBD8D-FCB0-434C-80B4-7B3FBA1A35FA}" type="presParOf" srcId="{1B0604F9-4BC8-4467-B736-9599BBB1A4D9}" destId="{E7FC3841-A06C-4102-81B4-B7FBBDC76C0B}" srcOrd="6" destOrd="0" presId="urn:microsoft.com/office/officeart/2005/8/layout/cycle2"/>
    <dgm:cxn modelId="{1DA59E6D-D183-43B3-9EC6-BA0845D89F2D}" type="presParOf" srcId="{1B0604F9-4BC8-4467-B736-9599BBB1A4D9}" destId="{90241673-4260-465D-8026-A437EDF5BB01}" srcOrd="7" destOrd="0" presId="urn:microsoft.com/office/officeart/2005/8/layout/cycle2"/>
    <dgm:cxn modelId="{EB399469-1234-4237-8E3D-4DB5C7F07BE5}" type="presParOf" srcId="{90241673-4260-465D-8026-A437EDF5BB01}" destId="{ED8B5CC7-98F0-4C74-B4F2-E1B662B3DBDF}" srcOrd="0" destOrd="0" presId="urn:microsoft.com/office/officeart/2005/8/layout/cycle2"/>
    <dgm:cxn modelId="{CFB58E8D-9FC4-4FB0-A8CA-A7DA90C00B01}" type="presParOf" srcId="{1B0604F9-4BC8-4467-B736-9599BBB1A4D9}" destId="{1B335BBB-EE84-4959-B622-268317A8EE60}" srcOrd="8" destOrd="0" presId="urn:microsoft.com/office/officeart/2005/8/layout/cycle2"/>
    <dgm:cxn modelId="{F89DD01D-7C5F-45A1-9B37-BEDDB25D938B}" type="presParOf" srcId="{1B0604F9-4BC8-4467-B736-9599BBB1A4D9}" destId="{6FC30703-DC2D-4B84-8C6B-174B073A088A}" srcOrd="9" destOrd="0" presId="urn:microsoft.com/office/officeart/2005/8/layout/cycle2"/>
    <dgm:cxn modelId="{93CEE229-1BAE-42CA-A91E-2A1476A69A84}" type="presParOf" srcId="{6FC30703-DC2D-4B84-8C6B-174B073A088A}" destId="{A0C89C7F-D1C5-43D4-8C60-151B53E3FFB3}" srcOrd="0" destOrd="0" presId="urn:microsoft.com/office/officeart/2005/8/layout/cycle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A1375D1-5864-4AC9-84ED-00E969387C1B}">
      <dsp:nvSpPr>
        <dsp:cNvPr id="0" name=""/>
        <dsp:cNvSpPr/>
      </dsp:nvSpPr>
      <dsp:spPr>
        <a:xfrm>
          <a:off x="2938869" y="503"/>
          <a:ext cx="1108685" cy="1108685"/>
        </a:xfrm>
        <a:prstGeom prst="ellipse">
          <a:avLst/>
        </a:prstGeom>
        <a:solidFill>
          <a:srgbClr val="ED7D31">
            <a:hueOff val="0"/>
            <a:satOff val="0"/>
            <a:lumOff val="0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480" tIns="30480" rIns="30480" bIns="3048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2400" kern="1200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السؤال</a:t>
          </a:r>
          <a:endParaRPr lang="en-US" sz="24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3101232" y="162866"/>
        <a:ext cx="783959" cy="783959"/>
      </dsp:txXfrm>
    </dsp:sp>
    <dsp:sp modelId="{B5B9E9E2-DEF1-4B04-8386-DDBBD3119DF4}">
      <dsp:nvSpPr>
        <dsp:cNvPr id="0" name=""/>
        <dsp:cNvSpPr/>
      </dsp:nvSpPr>
      <dsp:spPr>
        <a:xfrm rot="2160000">
          <a:off x="4012631" y="852376"/>
          <a:ext cx="295208" cy="374181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0"/>
            <a:satOff val="0"/>
            <a:lumOff val="0"/>
            <a:alphaOff val="0"/>
          </a:srgb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6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4021088" y="901184"/>
        <a:ext cx="206646" cy="224509"/>
      </dsp:txXfrm>
    </dsp:sp>
    <dsp:sp modelId="{B28996AE-1330-4ADC-AAB5-364032624F7E}">
      <dsp:nvSpPr>
        <dsp:cNvPr id="0" name=""/>
        <dsp:cNvSpPr/>
      </dsp:nvSpPr>
      <dsp:spPr>
        <a:xfrm>
          <a:off x="4286434" y="979567"/>
          <a:ext cx="1108685" cy="1108685"/>
        </a:xfrm>
        <a:prstGeom prst="ellipse">
          <a:avLst/>
        </a:prstGeom>
        <a:solidFill>
          <a:srgbClr val="ED7D31">
            <a:hueOff val="-363841"/>
            <a:satOff val="-20982"/>
            <a:lumOff val="2157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480" tIns="30480" rIns="30480" bIns="3048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2400" kern="1200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البحث</a:t>
          </a:r>
          <a:endParaRPr lang="en-US" sz="24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4448797" y="1141930"/>
        <a:ext cx="783959" cy="783959"/>
      </dsp:txXfrm>
    </dsp:sp>
    <dsp:sp modelId="{BA9DA9AF-FAC5-4FFA-98AD-952493E9C966}">
      <dsp:nvSpPr>
        <dsp:cNvPr id="0" name=""/>
        <dsp:cNvSpPr/>
      </dsp:nvSpPr>
      <dsp:spPr>
        <a:xfrm rot="6480000">
          <a:off x="4438392" y="2130951"/>
          <a:ext cx="295208" cy="374181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-363841"/>
            <a:satOff val="-20982"/>
            <a:lumOff val="2157"/>
            <a:alphaOff val="0"/>
          </a:srgb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6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 rot="10800000">
        <a:off x="4496357" y="2163673"/>
        <a:ext cx="206646" cy="224509"/>
      </dsp:txXfrm>
    </dsp:sp>
    <dsp:sp modelId="{16313D95-D8F8-4FF6-91AE-12BC24626682}">
      <dsp:nvSpPr>
        <dsp:cNvPr id="0" name=""/>
        <dsp:cNvSpPr/>
      </dsp:nvSpPr>
      <dsp:spPr>
        <a:xfrm>
          <a:off x="3771710" y="2563724"/>
          <a:ext cx="1108685" cy="1108685"/>
        </a:xfrm>
        <a:prstGeom prst="ellipse">
          <a:avLst/>
        </a:prstGeom>
        <a:solidFill>
          <a:srgbClr val="ED7D31">
            <a:hueOff val="-727682"/>
            <a:satOff val="-41964"/>
            <a:lumOff val="4314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480" tIns="30480" rIns="30480" bIns="3048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2400" kern="1200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التقييم النقدي</a:t>
          </a:r>
          <a:endParaRPr lang="en-US" sz="24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3934073" y="2726087"/>
        <a:ext cx="783959" cy="783959"/>
      </dsp:txXfrm>
    </dsp:sp>
    <dsp:sp modelId="{84DAFBFF-2251-47BC-B1CF-B067C2CA39A2}">
      <dsp:nvSpPr>
        <dsp:cNvPr id="0" name=""/>
        <dsp:cNvSpPr/>
      </dsp:nvSpPr>
      <dsp:spPr>
        <a:xfrm rot="10800000">
          <a:off x="3353962" y="2930976"/>
          <a:ext cx="295208" cy="374181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-727682"/>
            <a:satOff val="-41964"/>
            <a:lumOff val="4314"/>
            <a:alphaOff val="0"/>
          </a:srgb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6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 rot="10800000">
        <a:off x="3442524" y="3005812"/>
        <a:ext cx="206646" cy="224509"/>
      </dsp:txXfrm>
    </dsp:sp>
    <dsp:sp modelId="{E7FC3841-A06C-4102-81B4-B7FBBDC76C0B}">
      <dsp:nvSpPr>
        <dsp:cNvPr id="0" name=""/>
        <dsp:cNvSpPr/>
      </dsp:nvSpPr>
      <dsp:spPr>
        <a:xfrm>
          <a:off x="2106028" y="2563724"/>
          <a:ext cx="1108685" cy="1108685"/>
        </a:xfrm>
        <a:prstGeom prst="ellipse">
          <a:avLst/>
        </a:prstGeom>
        <a:solidFill>
          <a:srgbClr val="ED7D31">
            <a:hueOff val="-1091522"/>
            <a:satOff val="-62946"/>
            <a:lumOff val="6471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480" tIns="30480" rIns="30480" bIns="3048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2400" kern="1200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التطبيق</a:t>
          </a:r>
          <a:endParaRPr lang="en-US" sz="24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2268391" y="2726087"/>
        <a:ext cx="783959" cy="783959"/>
      </dsp:txXfrm>
    </dsp:sp>
    <dsp:sp modelId="{90241673-4260-465D-8026-A437EDF5BB01}">
      <dsp:nvSpPr>
        <dsp:cNvPr id="0" name=""/>
        <dsp:cNvSpPr/>
      </dsp:nvSpPr>
      <dsp:spPr>
        <a:xfrm rot="15120000">
          <a:off x="2257986" y="2146844"/>
          <a:ext cx="295208" cy="374181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-1091522"/>
            <a:satOff val="-62946"/>
            <a:lumOff val="6471"/>
            <a:alphaOff val="0"/>
          </a:srgb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6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 rot="10800000">
        <a:off x="2315951" y="2263794"/>
        <a:ext cx="206646" cy="224509"/>
      </dsp:txXfrm>
    </dsp:sp>
    <dsp:sp modelId="{1B335BBB-EE84-4959-B622-268317A8EE60}">
      <dsp:nvSpPr>
        <dsp:cNvPr id="0" name=""/>
        <dsp:cNvSpPr/>
      </dsp:nvSpPr>
      <dsp:spPr>
        <a:xfrm>
          <a:off x="1591304" y="979567"/>
          <a:ext cx="1108685" cy="1108685"/>
        </a:xfrm>
        <a:prstGeom prst="ellipse">
          <a:avLst/>
        </a:prstGeom>
        <a:solidFill>
          <a:srgbClr val="ED7D31">
            <a:hueOff val="-1455363"/>
            <a:satOff val="-83928"/>
            <a:lumOff val="8628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480" tIns="30480" rIns="30480" bIns="3048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2400" kern="1200">
              <a:solidFill>
                <a:sysClr val="window" lastClr="FFFFFF"/>
              </a:solidFill>
              <a:latin typeface="Calibri" panose="020F0502020204030204"/>
              <a:ea typeface="+mn-ea"/>
              <a:cs typeface="Arial" panose="020B0604020202020204" pitchFamily="34" charset="0"/>
            </a:rPr>
            <a:t>تقويم الأداء</a:t>
          </a:r>
          <a:endParaRPr lang="en-US" sz="24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1753667" y="1141930"/>
        <a:ext cx="783959" cy="783959"/>
      </dsp:txXfrm>
    </dsp:sp>
    <dsp:sp modelId="{6FC30703-DC2D-4B84-8C6B-174B073A088A}">
      <dsp:nvSpPr>
        <dsp:cNvPr id="0" name=""/>
        <dsp:cNvSpPr/>
      </dsp:nvSpPr>
      <dsp:spPr>
        <a:xfrm rot="19440000">
          <a:off x="2665066" y="862198"/>
          <a:ext cx="295208" cy="374181"/>
        </a:xfrm>
        <a:prstGeom prst="rightArrow">
          <a:avLst>
            <a:gd name="adj1" fmla="val 60000"/>
            <a:gd name="adj2" fmla="val 50000"/>
          </a:avLst>
        </a:prstGeom>
        <a:solidFill>
          <a:srgbClr val="ED7D31">
            <a:hueOff val="-1455363"/>
            <a:satOff val="-83928"/>
            <a:lumOff val="8628"/>
            <a:alphaOff val="0"/>
          </a:srgb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600" kern="120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2673523" y="963062"/>
        <a:ext cx="206646" cy="22450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ycle2">
  <dgm:title val=""/>
  <dgm:desc val=""/>
  <dgm:catLst>
    <dgm:cat type="cycle" pri="1000"/>
    <dgm:cat type="convert" pri="10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choose name="Name2">
          <dgm:if name="Name3" axis="ch" ptType="node" func="cnt" op="gt" val="2">
            <dgm:alg type="cycle">
              <dgm:param type="stAng" val="0"/>
              <dgm:param type="spanAng" val="360"/>
            </dgm:alg>
          </dgm:if>
          <dgm:else name="Name4">
            <dgm:alg type="cycle">
              <dgm:param type="stAng" val="-90"/>
              <dgm:param type="spanAng" val="360"/>
            </dgm:alg>
          </dgm:else>
        </dgm:choose>
      </dgm:if>
      <dgm:else name="Name5">
        <dgm:choose name="Name6">
          <dgm:if name="Name7" axis="ch" ptType="node" func="cnt" op="gt" val="2">
            <dgm:alg type="cycle">
              <dgm:param type="stAng" val="0"/>
              <dgm:param type="spanAng" val="-360"/>
            </dgm:alg>
          </dgm:if>
          <dgm:else name="Name8">
            <dgm:alg type="cycle">
              <dgm:param type="stAng" val="90"/>
              <dgm:param type="spanAng" val="-360"/>
            </dgm:alg>
          </dgm:else>
        </dgm:choose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w" for="ch" ptType="sibTrans" refType="w" refFor="ch" refPtType="node" op="equ" fact="0.25"/>
      <dgm:constr type="sibSp" refType="w" refFor="ch" refPtType="node" fact="0.5"/>
      <dgm:constr type="primFontSz" for="ch" ptType="node" op="equ" val="65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ellipse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sibTransForEach" axis="followSib" ptType="sibTrans" hideLastTrans="0" cnt="1">
            <dgm:layoutNode name="sibTrans">
              <dgm:choose name="Name11">
                <dgm:if name="Name12" axis="par ch" ptType="doc node" func="cnt" op="lt" val="3">
                  <dgm:alg type="conn">
                    <dgm:param type="begPts" val="radial"/>
                    <dgm:param type="endPts" val="radial"/>
                  </dgm:alg>
                </dgm:if>
                <dgm:else name="Name13">
                  <dgm:alg type="conn">
                    <dgm:param type="begPts" val="auto"/>
                    <dgm:param type="endPts" val="auto"/>
                  </dgm:alg>
                </dgm:else>
              </dgm:choose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1.35"/>
                <dgm:constr type="connDist"/>
                <dgm:constr type="w" for="ch" refType="connDist" fact="0.45"/>
                <dgm:constr type="h" for="ch" refType="h"/>
              </dgm:constrLst>
              <dgm:ruleLst/>
              <dgm:layoutNode name="connectorText">
                <dgm:alg type="tx">
                  <dgm:param type="autoTxRot" val="grav"/>
                </dgm:alg>
                <dgm:shape xmlns:r="http://schemas.openxmlformats.org/officeDocument/2006/relationships" type="conn" r:blip="" hideGeom="1">
                  <dgm:adjLst/>
                </dgm:shape>
                <dgm:presOf axis="self"/>
                <dgm:constrLst>
                  <dgm:constr type="lMarg"/>
                  <dgm:constr type="rMarg"/>
                  <dgm:constr type="tMarg"/>
                  <dgm:constr type="bMarg"/>
                </dgm:constrLst>
                <dgm:ruleLst>
                  <dgm:rule type="primFontSz" val="5" fact="NaN" max="NaN"/>
                </dgm:ruleLst>
              </dgm:layoutNode>
            </dgm:layoutNode>
          </dgm:forEach>
        </dgm:if>
        <dgm:else name="Name14"/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02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7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8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9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12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1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8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23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72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8B0EF-3C06-4365-85ED-831195B7F133}" type="datetimeFigureOut">
              <a:rPr lang="en-US" smtClean="0"/>
              <a:t>6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3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16/j.rlfa.2017.05.004" TargetMode="External"/><Relationship Id="rId2" Type="http://schemas.openxmlformats.org/officeDocument/2006/relationships/hyperlink" Target="https://doi.org/10.1136/adc.2005.071761" TargetMode="Externa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doi.org/10.1136/bmj.310.6987.1122" TargetMode="External"/><Relationship Id="rId4" Type="http://schemas.openxmlformats.org/officeDocument/2006/relationships/hyperlink" Target="https://doi.org/10.1186/1472-6920-13-77" TargetMode="Externa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f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gi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ar-SY" sz="4800" dirty="0">
                <a:solidFill>
                  <a:schemeClr val="accent2">
                    <a:lumMod val="50000"/>
                  </a:schemeClr>
                </a:solidFill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طب المسند بالدليل في ظروف العمل السريري</a:t>
            </a:r>
            <a:endParaRPr lang="en-US" sz="4800" dirty="0">
              <a:solidFill>
                <a:schemeClr val="accent2">
                  <a:lumMod val="50000"/>
                </a:schemeClr>
              </a:solidFill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rtl="1"/>
            <a:r>
              <a:rPr lang="ar-SY" sz="5400" dirty="0">
                <a:solidFill>
                  <a:schemeClr val="accent3">
                    <a:lumMod val="75000"/>
                  </a:schemeClr>
                </a:solidFill>
              </a:rPr>
              <a:t>الوحدة الأولى</a:t>
            </a:r>
          </a:p>
          <a:p>
            <a:r>
              <a:rPr lang="ar-SY" sz="3200" dirty="0"/>
              <a:t>مراحل الطب المسند بالدليل</a:t>
            </a:r>
            <a:endParaRPr lang="en-US" sz="3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8748"/>
            <a:ext cx="2479677" cy="19634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5382" y="799197"/>
            <a:ext cx="432261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جامعة الافتراضية السورية</a:t>
            </a:r>
          </a:p>
          <a:p>
            <a:pPr algn="r" rtl="1"/>
            <a:endParaRPr lang="ar-SY" sz="2000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ماجستير التعليم الطبي</a:t>
            </a:r>
            <a:endParaRPr lang="en-US" sz="2800" b="1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36183" y="5349873"/>
            <a:ext cx="173181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r-SY" sz="2800" dirty="0"/>
              <a:t>إعداد وتقديم:</a:t>
            </a:r>
            <a:br>
              <a:rPr lang="ar-SY" sz="2800" dirty="0"/>
            </a:br>
            <a:r>
              <a:rPr lang="ar-SY" sz="2800" dirty="0"/>
              <a:t>يزن قنجراوي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0" y="5351891"/>
            <a:ext cx="233108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ar-SY" sz="2800" dirty="0"/>
              <a:t>بإشراف:</a:t>
            </a:r>
            <a:br>
              <a:rPr lang="ar-SY" sz="2800" dirty="0"/>
            </a:br>
            <a:r>
              <a:rPr lang="ar-SY" sz="2800" dirty="0"/>
              <a:t>أ. د. ميسون دشاش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677004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6837" y="490537"/>
            <a:ext cx="9458325" cy="5876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7734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B6B65C-7340-49BB-A1AC-C48A1ED398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مراجع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146033-30AA-420F-B609-704055A4C7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dirty="0" err="1"/>
              <a:t>Akobeng</a:t>
            </a:r>
            <a:r>
              <a:rPr lang="en-US" dirty="0"/>
              <a:t>, A. K. (2005). Principles of evidence based medicine. </a:t>
            </a:r>
            <a:r>
              <a:rPr lang="en-US" i="1" dirty="0"/>
              <a:t>Archives of Disease in Childhood</a:t>
            </a:r>
            <a:r>
              <a:rPr lang="en-US" dirty="0"/>
              <a:t>, </a:t>
            </a:r>
            <a:r>
              <a:rPr lang="en-US" i="1" dirty="0"/>
              <a:t>90</a:t>
            </a:r>
            <a:r>
              <a:rPr lang="en-US" dirty="0"/>
              <a:t>(8), 837–840. </a:t>
            </a:r>
            <a:r>
              <a:rPr lang="en-US" u="sng" dirty="0">
                <a:hlinkClick r:id="rId2"/>
              </a:rPr>
              <a:t>https://doi.org/10.1136/adc.2005.071761</a:t>
            </a:r>
            <a:endParaRPr lang="en-US" u="sng" dirty="0"/>
          </a:p>
          <a:p>
            <a:r>
              <a:rPr lang="en-US" dirty="0"/>
              <a:t>Isaksen, J. (2017). Evidence-based practice: Steps towards a better clinical practice. </a:t>
            </a:r>
            <a:r>
              <a:rPr lang="en-US" dirty="0" err="1"/>
              <a:t>Revista</a:t>
            </a:r>
            <a:r>
              <a:rPr lang="en-US" dirty="0"/>
              <a:t> de </a:t>
            </a:r>
            <a:r>
              <a:rPr lang="en-US" dirty="0" err="1"/>
              <a:t>Logopedia</a:t>
            </a:r>
            <a:r>
              <a:rPr lang="en-US" dirty="0"/>
              <a:t>, </a:t>
            </a:r>
            <a:r>
              <a:rPr lang="en-US" dirty="0" err="1"/>
              <a:t>Foniatría</a:t>
            </a:r>
            <a:r>
              <a:rPr lang="en-US" dirty="0"/>
              <a:t> y </a:t>
            </a:r>
            <a:r>
              <a:rPr lang="en-US" dirty="0" err="1"/>
              <a:t>Audiología</a:t>
            </a:r>
            <a:r>
              <a:rPr lang="en-US" dirty="0"/>
              <a:t>. </a:t>
            </a:r>
            <a:r>
              <a:rPr lang="en-US" dirty="0">
                <a:hlinkClick r:id="rId3"/>
              </a:rPr>
              <a:t>https://doi.org/10.1016/j.rlfa.2017.05.004</a:t>
            </a:r>
            <a:endParaRPr lang="en-US" dirty="0"/>
          </a:p>
          <a:p>
            <a:r>
              <a:rPr lang="en-US" dirty="0" err="1"/>
              <a:t>Karagiannis</a:t>
            </a:r>
            <a:r>
              <a:rPr lang="en-US" dirty="0"/>
              <a:t>, T. (2019). The importance of applying evidence-based medicine in clinical practice. In Management of Hypertension (pp. 3–17). Springer.</a:t>
            </a:r>
          </a:p>
          <a:p>
            <a:r>
              <a:rPr lang="en-US" i="1" dirty="0"/>
              <a:t>Resources for Evidence-Based Practice: Forming Questions</a:t>
            </a:r>
            <a:r>
              <a:rPr lang="en-US" dirty="0"/>
              <a:t>. (2021). McMaster University Health Sciences.</a:t>
            </a:r>
          </a:p>
          <a:p>
            <a:r>
              <a:rPr lang="en-US" dirty="0" err="1"/>
              <a:t>Rohwer</a:t>
            </a:r>
            <a:r>
              <a:rPr lang="en-US" dirty="0"/>
              <a:t>, A., Young, T., &amp; Van Schalkwyk, S. (2013). Effective or just practical? An evaluation of an online postgraduate module on evidence-based medicine (EBM). BMC Medical Education, 13(1). </a:t>
            </a:r>
            <a:r>
              <a:rPr lang="en-US" dirty="0">
                <a:hlinkClick r:id="rId4"/>
              </a:rPr>
              <a:t>https://doi.org/10.1186/1472-6920-13-77</a:t>
            </a:r>
            <a:endParaRPr lang="en-US" dirty="0"/>
          </a:p>
          <a:p>
            <a:r>
              <a:rPr lang="en-US" dirty="0"/>
              <a:t>Rosenberg, W., &amp; Donald, A. (1995). Evidence based medicine: An Approach to clinical problem-solving. </a:t>
            </a:r>
            <a:r>
              <a:rPr lang="en-US" dirty="0" err="1"/>
              <a:t>Bmj</a:t>
            </a:r>
            <a:r>
              <a:rPr lang="en-US" dirty="0"/>
              <a:t>, 310(6987), 1122. </a:t>
            </a:r>
            <a:r>
              <a:rPr lang="en-US" dirty="0">
                <a:hlinkClick r:id="rId5"/>
              </a:rPr>
              <a:t>https://doi.org/10.1136/bmj.310.6987.1122</a:t>
            </a:r>
            <a:endParaRPr lang="en-US" dirty="0"/>
          </a:p>
          <a:p>
            <a:endParaRPr lang="en-US" dirty="0"/>
          </a:p>
          <a:p>
            <a:endParaRPr lang="ar-SY" dirty="0"/>
          </a:p>
        </p:txBody>
      </p:sp>
    </p:spTree>
    <p:extLst>
      <p:ext uri="{BB962C8B-B14F-4D97-AF65-F5344CB8AC3E}">
        <p14:creationId xmlns:p14="http://schemas.microsoft.com/office/powerpoint/2010/main" val="12055436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أهداف التعليمية: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r" rtl="1"/>
            <a:r>
              <a:rPr lang="ar-SY" sz="3600" dirty="0"/>
              <a:t>عند الانتهاء من هذه الوحدة ستكون قادر على:</a:t>
            </a:r>
          </a:p>
          <a:p>
            <a:pPr algn="r" rtl="1">
              <a:lnSpc>
                <a:spcPct val="200000"/>
              </a:lnSpc>
            </a:pPr>
            <a:r>
              <a:rPr lang="ar-SY" dirty="0"/>
              <a:t>1)  تعريف مفهوم الطب المسند بالدليل.</a:t>
            </a:r>
          </a:p>
          <a:p>
            <a:pPr algn="r" rtl="1">
              <a:lnSpc>
                <a:spcPct val="200000"/>
              </a:lnSpc>
            </a:pPr>
            <a:r>
              <a:rPr lang="ar-SY" dirty="0"/>
              <a:t>2)  تعداد فوائد الطب المسند بالدليل.</a:t>
            </a:r>
          </a:p>
          <a:p>
            <a:pPr algn="r" rtl="1">
              <a:lnSpc>
                <a:spcPct val="200000"/>
              </a:lnSpc>
            </a:pPr>
            <a:r>
              <a:rPr lang="ar-SY" b="1" dirty="0"/>
              <a:t>3) شرح مراحل الطب المسند بالدليل الخمسة.</a:t>
            </a:r>
            <a:endParaRPr lang="en-US" b="1" dirty="0"/>
          </a:p>
          <a:p>
            <a:pPr>
              <a:lnSpc>
                <a:spcPct val="200000"/>
              </a:lnSpc>
            </a:pP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15803"/>
            <a:ext cx="4164042" cy="2770981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1453628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مراحل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r" rtl="1"/>
            <a:r>
              <a:rPr lang="ar-SY" sz="3600" dirty="0"/>
              <a:t>تتضمن ممارسة الطب المسند بالدليل خمس مراحل:</a:t>
            </a:r>
          </a:p>
          <a:p>
            <a:pPr algn="r" rtl="1"/>
            <a:r>
              <a:rPr lang="ar-SY" dirty="0"/>
              <a:t> المرحلة الأولى: تحويل المشكلة السريرية إلى </a:t>
            </a:r>
            <a:r>
              <a:rPr lang="ar-SY" dirty="0">
                <a:solidFill>
                  <a:srgbClr val="FF0000"/>
                </a:solidFill>
              </a:rPr>
              <a:t>سؤال قابل للحل</a:t>
            </a:r>
          </a:p>
          <a:p>
            <a:pPr algn="r" rtl="1"/>
            <a:r>
              <a:rPr lang="ar-SY" dirty="0"/>
              <a:t>المرحلة الثانية: </a:t>
            </a:r>
            <a:r>
              <a:rPr lang="ar-SY" dirty="0">
                <a:solidFill>
                  <a:srgbClr val="FF0000"/>
                </a:solidFill>
              </a:rPr>
              <a:t>البحث</a:t>
            </a:r>
            <a:r>
              <a:rPr lang="ar-SY" dirty="0"/>
              <a:t> عن أفضل دليل</a:t>
            </a:r>
          </a:p>
          <a:p>
            <a:pPr algn="r" rtl="1"/>
            <a:r>
              <a:rPr lang="ar-SY" dirty="0"/>
              <a:t>المرحلة الثالثة: </a:t>
            </a:r>
            <a:r>
              <a:rPr lang="ar-SY" dirty="0">
                <a:solidFill>
                  <a:srgbClr val="FF0000"/>
                </a:solidFill>
              </a:rPr>
              <a:t>تقييم</a:t>
            </a:r>
            <a:r>
              <a:rPr lang="ar-SY" dirty="0"/>
              <a:t> هذا الدليل بشكل نقدي</a:t>
            </a:r>
          </a:p>
          <a:p>
            <a:pPr algn="r" rtl="1"/>
            <a:r>
              <a:rPr lang="ar-SY" dirty="0"/>
              <a:t>المرحلة الرابعة: </a:t>
            </a:r>
            <a:r>
              <a:rPr lang="ar-SY" dirty="0">
                <a:solidFill>
                  <a:srgbClr val="FF0000"/>
                </a:solidFill>
              </a:rPr>
              <a:t>تطبيق</a:t>
            </a:r>
            <a:r>
              <a:rPr lang="ar-SY" dirty="0"/>
              <a:t> النتائج التي توصلنا إليها</a:t>
            </a:r>
          </a:p>
          <a:p>
            <a:pPr algn="r" rtl="1"/>
            <a:r>
              <a:rPr lang="ar-SY" dirty="0"/>
              <a:t>المرحلة الخامسة: </a:t>
            </a:r>
            <a:r>
              <a:rPr lang="ar-SY" dirty="0">
                <a:solidFill>
                  <a:srgbClr val="FF0000"/>
                </a:solidFill>
              </a:rPr>
              <a:t>تقويم</a:t>
            </a:r>
            <a:r>
              <a:rPr lang="ar-SY" dirty="0"/>
              <a:t> أداءنا.</a:t>
            </a:r>
          </a:p>
          <a:p>
            <a:pPr algn="r" rtl="1"/>
            <a:endParaRPr lang="ar-SY" dirty="0"/>
          </a:p>
          <a:p>
            <a:pPr algn="r" rtl="1"/>
            <a:endParaRPr lang="ar-SY" dirty="0"/>
          </a:p>
          <a:p>
            <a:pPr marL="0" indent="0" algn="r" rtl="1">
              <a:buNone/>
            </a:pP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</a:p>
          <a:p>
            <a:pPr algn="r" rtl="1"/>
            <a:endParaRPr lang="en-US" dirty="0"/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8C706019-AE64-4C10-A549-346A74D978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5411704"/>
              </p:ext>
            </p:extLst>
          </p:nvPr>
        </p:nvGraphicFramePr>
        <p:xfrm>
          <a:off x="-782571" y="1825625"/>
          <a:ext cx="6986424" cy="367291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Rounded Rectangle 5">
            <a:extLst>
              <a:ext uri="{FF2B5EF4-FFF2-40B4-BE49-F238E27FC236}">
                <a16:creationId xmlns:a16="http://schemas.microsoft.com/office/drawing/2014/main" id="{4CE3D31E-95C0-4DE5-9A4A-514B925A75F9}"/>
              </a:ext>
            </a:extLst>
          </p:cNvPr>
          <p:cNvSpPr/>
          <p:nvPr/>
        </p:nvSpPr>
        <p:spPr>
          <a:xfrm>
            <a:off x="1297858" y="5677719"/>
            <a:ext cx="2610465" cy="634181"/>
          </a:xfrm>
          <a:prstGeom prst="round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(</a:t>
            </a:r>
            <a:r>
              <a:rPr lang="en-US" dirty="0" err="1"/>
              <a:t>Rohwer</a:t>
            </a:r>
            <a:r>
              <a:rPr lang="en-US" dirty="0"/>
              <a:t> et al., 2013)</a:t>
            </a:r>
          </a:p>
        </p:txBody>
      </p:sp>
    </p:spTree>
    <p:extLst>
      <p:ext uri="{BB962C8B-B14F-4D97-AF65-F5344CB8AC3E}">
        <p14:creationId xmlns:p14="http://schemas.microsoft.com/office/powerpoint/2010/main" val="10284992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مراحل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r>
              <a:rPr lang="ar-SA" dirty="0"/>
              <a:t>1) </a:t>
            </a:r>
            <a:r>
              <a:rPr lang="ar-SA" sz="3600" dirty="0"/>
              <a:t>صياغة سؤال قابل للحل:</a:t>
            </a:r>
          </a:p>
          <a:p>
            <a:pPr algn="r" rtl="1"/>
            <a:r>
              <a:rPr lang="ar-SA" dirty="0"/>
              <a:t>عند التماس الأول مع المريض ستكون </a:t>
            </a:r>
          </a:p>
          <a:p>
            <a:pPr marL="0" indent="0" algn="r" rtl="1">
              <a:buNone/>
            </a:pPr>
            <a:r>
              <a:rPr lang="ar-SA" dirty="0"/>
              <a:t>الأسئلة كثيرة وغير منظمة وغير واضحة.</a:t>
            </a:r>
            <a:endParaRPr lang="en-US" dirty="0"/>
          </a:p>
          <a:p>
            <a:pPr algn="r" rtl="1"/>
            <a:r>
              <a:rPr lang="ar-SA" dirty="0"/>
              <a:t> بينما يجب أن نبدأ </a:t>
            </a:r>
            <a:r>
              <a:rPr lang="ar-SA" dirty="0">
                <a:solidFill>
                  <a:srgbClr val="FF0000"/>
                </a:solidFill>
              </a:rPr>
              <a:t>بسؤال سريري مصاغ بشكل محكم</a:t>
            </a:r>
            <a:r>
              <a:rPr lang="ar-SA" dirty="0"/>
              <a:t>. </a:t>
            </a:r>
          </a:p>
          <a:p>
            <a:pPr algn="r" rtl="1"/>
            <a:r>
              <a:rPr lang="ar-SA" dirty="0"/>
              <a:t>مما يعني بأنه يجب علينا أن نطور المهارة اللازمة من أجل القدرة </a:t>
            </a:r>
          </a:p>
          <a:p>
            <a:pPr marL="0" indent="0" algn="r" rtl="1">
              <a:buNone/>
            </a:pPr>
            <a:r>
              <a:rPr lang="ar-SA" dirty="0"/>
              <a:t>على تحويل الفجوة في المعلومات لدينا إلى سؤال قابل للحل.</a:t>
            </a:r>
          </a:p>
          <a:p>
            <a:pPr marL="0" indent="0" algn="r" rtl="1">
              <a:buNone/>
            </a:pPr>
            <a:endParaRPr lang="ar-SA" dirty="0"/>
          </a:p>
          <a:p>
            <a:pPr marL="0" indent="0" algn="r" rtl="1">
              <a:buNone/>
            </a:pP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</a:p>
          <a:p>
            <a:pPr marL="0" indent="0" algn="r" rtl="1">
              <a:buNone/>
            </a:pP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154E534-D44C-4AEF-BA3E-8495DDAE2A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305" y="1825625"/>
            <a:ext cx="3157024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20218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مراحل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just" rtl="1"/>
            <a:r>
              <a:rPr lang="ar-SY" dirty="0"/>
              <a:t>1) </a:t>
            </a:r>
            <a:r>
              <a:rPr lang="ar-SA" sz="3600" dirty="0"/>
              <a:t>صياغة سؤال قابل للحل:</a:t>
            </a:r>
            <a:endParaRPr lang="en-US" sz="3600" dirty="0"/>
          </a:p>
          <a:p>
            <a:pPr lvl="0" algn="just" rtl="1"/>
            <a:r>
              <a:rPr lang="ar-SY" dirty="0"/>
              <a:t>هنالك نوعين رئيسيين من الأسئلة:</a:t>
            </a:r>
          </a:p>
          <a:p>
            <a:pPr lvl="0" algn="just" rtl="1"/>
            <a:r>
              <a:rPr lang="ar-SY" dirty="0">
                <a:solidFill>
                  <a:srgbClr val="FF0000"/>
                </a:solidFill>
              </a:rPr>
              <a:t>أسئلة تمهيدية: </a:t>
            </a:r>
            <a:r>
              <a:rPr lang="ar-SY" dirty="0"/>
              <a:t>تعد هذه الأسئلة عامة ووظيفتها </a:t>
            </a:r>
          </a:p>
          <a:p>
            <a:pPr marL="0" lvl="0" indent="0" algn="just" rtl="1">
              <a:buNone/>
            </a:pPr>
            <a:r>
              <a:rPr lang="ar-SY" dirty="0"/>
              <a:t>الرئيسية هي إعطاء معلومات رئيسية حول مفهوم محدد. </a:t>
            </a:r>
            <a:endParaRPr lang="en-US" dirty="0"/>
          </a:p>
          <a:p>
            <a:pPr algn="just" rtl="1"/>
            <a:r>
              <a:rPr lang="ar-SY" dirty="0">
                <a:solidFill>
                  <a:srgbClr val="FF0000"/>
                </a:solidFill>
              </a:rPr>
              <a:t>أسئلة استطلاعية: </a:t>
            </a:r>
            <a:r>
              <a:rPr lang="ar-SY" dirty="0"/>
              <a:t>تعنى هذه الأسئلة بربط مفاهيم عديدة </a:t>
            </a:r>
          </a:p>
          <a:p>
            <a:pPr marL="0" indent="0" algn="just" rtl="1">
              <a:buNone/>
            </a:pPr>
            <a:r>
              <a:rPr lang="ar-SY" dirty="0"/>
              <a:t>بحالة سريرية معينة أو موضوع بحثي معين.</a:t>
            </a:r>
          </a:p>
          <a:p>
            <a:pPr algn="just" rtl="1"/>
            <a:endParaRPr lang="en-US" dirty="0"/>
          </a:p>
          <a:p>
            <a:pPr algn="just" rtl="1"/>
            <a:endParaRPr lang="ar-SY" dirty="0"/>
          </a:p>
          <a:p>
            <a:pPr marL="0" indent="0" algn="just" rtl="1">
              <a:buNone/>
            </a:pPr>
            <a:r>
              <a:rPr lang="en-US" sz="2000" dirty="0"/>
              <a:t>(</a:t>
            </a:r>
            <a:r>
              <a:rPr lang="en-US" sz="2000" i="1" dirty="0"/>
              <a:t>Resources for Evidence-Based Practice: Forming Questions</a:t>
            </a:r>
            <a:r>
              <a:rPr lang="en-US" sz="2000" dirty="0"/>
              <a:t>, 2021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71F2704-2C0E-423D-B27C-2943180904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394145"/>
            <a:ext cx="3311769" cy="20697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67696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مراحل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r>
              <a:rPr lang="ar-SY" dirty="0"/>
              <a:t>2) </a:t>
            </a:r>
            <a:r>
              <a:rPr lang="ar-SY" sz="3900" dirty="0"/>
              <a:t>إيجاد الدليل:</a:t>
            </a:r>
            <a:endParaRPr lang="en-US" sz="3900" dirty="0"/>
          </a:p>
          <a:p>
            <a:pPr algn="r" rtl="1"/>
            <a:r>
              <a:rPr lang="ar-SY" dirty="0"/>
              <a:t>أصبح الأمر الآن أسهل بكثير مما كان عليه قبل بضع سنوات فقط. </a:t>
            </a:r>
            <a:r>
              <a:rPr lang="en-US" sz="2000" dirty="0"/>
              <a:t>(Isaksen, 2017)</a:t>
            </a:r>
            <a:r>
              <a:rPr lang="ar-SY" dirty="0"/>
              <a:t> </a:t>
            </a:r>
          </a:p>
          <a:p>
            <a:pPr algn="r" rtl="1"/>
            <a:r>
              <a:rPr lang="ar-SY" dirty="0"/>
              <a:t>مهارة البحث الفعال من الجوانب الهامة في الطب المسند بالدليل. </a:t>
            </a:r>
          </a:p>
          <a:p>
            <a:pPr algn="r" rtl="1"/>
            <a:r>
              <a:rPr lang="ar-SY" dirty="0">
                <a:solidFill>
                  <a:srgbClr val="FF0000"/>
                </a:solidFill>
              </a:rPr>
              <a:t>الخضوع لتدريب </a:t>
            </a:r>
            <a:r>
              <a:rPr lang="ar-SY" dirty="0"/>
              <a:t>في مهارات البحث. </a:t>
            </a: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  <a:endParaRPr lang="ar-SY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611CA8A-864B-4136-9DEA-14D7DFD89B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56784" y="4540556"/>
            <a:ext cx="2143125" cy="214312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322942F-3602-42CD-83C3-028F2E17398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1474" y="3429000"/>
            <a:ext cx="3429000" cy="3429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1544DCF-8CA0-4BC4-B504-37BC179407F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6943" y="4957763"/>
            <a:ext cx="5695950" cy="121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19398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مراحل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r>
              <a:rPr lang="ar-SY" dirty="0"/>
              <a:t>3) </a:t>
            </a:r>
            <a:r>
              <a:rPr lang="ar-SY" sz="3600" dirty="0"/>
              <a:t>تقييم الدليل:</a:t>
            </a:r>
            <a:endParaRPr lang="en-US" sz="3600" dirty="0"/>
          </a:p>
          <a:p>
            <a:pPr algn="r" rtl="1"/>
            <a:r>
              <a:rPr lang="ar-SY" dirty="0"/>
              <a:t>سنحصل على العديد من المقالات حول الموضوع الذي قمنا بالبحث عنه. </a:t>
            </a:r>
          </a:p>
          <a:p>
            <a:pPr algn="r" rtl="1"/>
            <a:r>
              <a:rPr lang="ar-SY" dirty="0"/>
              <a:t>مختلفة من حيث الجودة والقوة العلمية </a:t>
            </a:r>
          </a:p>
          <a:p>
            <a:pPr marL="0" indent="0" algn="r" rtl="1">
              <a:buNone/>
            </a:pPr>
            <a:r>
              <a:rPr lang="ar-SY" dirty="0"/>
              <a:t>والقدرة على تطبيق الأدلة في ظروفنا الخاصة.</a:t>
            </a:r>
            <a:r>
              <a:rPr lang="ar-SY" b="1" dirty="0"/>
              <a:t> </a:t>
            </a:r>
          </a:p>
          <a:p>
            <a:pPr algn="r" rtl="1"/>
            <a:r>
              <a:rPr lang="ar-SY" dirty="0"/>
              <a:t>طرح </a:t>
            </a:r>
            <a:r>
              <a:rPr lang="ar-SY" dirty="0">
                <a:solidFill>
                  <a:srgbClr val="FF0000"/>
                </a:solidFill>
              </a:rPr>
              <a:t>أسئلة قليلة ولكن مفتاحية</a:t>
            </a:r>
            <a:r>
              <a:rPr lang="ar-SY" dirty="0"/>
              <a:t>. </a:t>
            </a: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  <a:endParaRPr lang="ar-SY" sz="2000" dirty="0"/>
          </a:p>
          <a:p>
            <a:pPr algn="r" rtl="1"/>
            <a:r>
              <a:rPr lang="ar-SY" dirty="0"/>
              <a:t>يمكن لهذه المهارات أن تكتسب من خلال دورات </a:t>
            </a:r>
          </a:p>
          <a:p>
            <a:pPr marL="0" indent="0" algn="r" rtl="1">
              <a:buNone/>
            </a:pPr>
            <a:r>
              <a:rPr lang="ar-SY" dirty="0"/>
              <a:t>تعليمية وفي الظروف السريرية. </a:t>
            </a:r>
            <a:r>
              <a:rPr lang="en-US" sz="2000" dirty="0"/>
              <a:t>(Rosenberg &amp; Donald, 1995)</a:t>
            </a:r>
          </a:p>
          <a:p>
            <a:pPr algn="r" rtl="1"/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4389C7E-9327-449E-80EC-329C845D21B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098" y="2625786"/>
            <a:ext cx="4364892" cy="4364892"/>
          </a:xfrm>
          <a:prstGeom prst="ellipse">
            <a:avLst/>
          </a:prstGeom>
          <a:ln>
            <a:noFill/>
          </a:ln>
          <a:effectLst>
            <a:softEdge rad="112500"/>
          </a:effectLst>
        </p:spPr>
      </p:pic>
    </p:spTree>
    <p:extLst>
      <p:ext uri="{BB962C8B-B14F-4D97-AF65-F5344CB8AC3E}">
        <p14:creationId xmlns:p14="http://schemas.microsoft.com/office/powerpoint/2010/main" val="41221754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مراحل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just" rtl="1"/>
            <a:r>
              <a:rPr lang="ar-SY" b="1" dirty="0"/>
              <a:t>المرحلة الرابعة:</a:t>
            </a:r>
            <a:r>
              <a:rPr lang="ar-SY" dirty="0"/>
              <a:t> تطبيق الدليل:</a:t>
            </a:r>
            <a:endParaRPr lang="en-US" dirty="0"/>
          </a:p>
          <a:p>
            <a:pPr algn="just" rtl="1"/>
            <a:r>
              <a:rPr lang="ar-SY" dirty="0"/>
              <a:t>نأخذ قيم المريض وظروفه الخاصة بعين الاعتبار. </a:t>
            </a:r>
          </a:p>
          <a:p>
            <a:pPr algn="just" rtl="1"/>
            <a:r>
              <a:rPr lang="ar-SY" dirty="0"/>
              <a:t>مناقشة فعالية الدليل والمخاطر المتعلقة بتطبيقه وتكاليفه </a:t>
            </a:r>
          </a:p>
          <a:p>
            <a:pPr marL="0" indent="0" algn="just" rtl="1">
              <a:buNone/>
            </a:pPr>
            <a:r>
              <a:rPr lang="ar-SY" dirty="0"/>
              <a:t>مع المريض لإعطائه فرصة اتخاذ قرار مبني على كافة المعطيات.</a:t>
            </a:r>
          </a:p>
          <a:p>
            <a:pPr algn="just" rtl="1"/>
            <a:r>
              <a:rPr lang="ar-SY" dirty="0"/>
              <a:t>توافر مصادر تطبيق هذا الدليل في المشفى أو العيادة حيث نعمل. 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marL="0" indent="0" algn="just" rtl="1">
              <a:buNone/>
            </a:pP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</a:p>
          <a:p>
            <a:pPr algn="r" rtl="1"/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CE2BE0E-50A5-4F8D-A2CD-79ADCAEED5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219" y="4234374"/>
            <a:ext cx="6166338" cy="24316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23631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مراحل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Y" dirty="0"/>
              <a:t>5) </a:t>
            </a:r>
            <a:r>
              <a:rPr lang="ar-SY" sz="3600" dirty="0"/>
              <a:t>تقويم الأداء:</a:t>
            </a:r>
            <a:endParaRPr lang="en-US" sz="3600" dirty="0"/>
          </a:p>
          <a:p>
            <a:pPr algn="just" rtl="1"/>
            <a:r>
              <a:rPr lang="ar-SY" dirty="0"/>
              <a:t>نقوم بتقويم هذه المقاربة بشكل دوري. </a:t>
            </a:r>
          </a:p>
          <a:p>
            <a:pPr algn="just" rtl="1"/>
            <a:r>
              <a:rPr lang="ar-SY" dirty="0"/>
              <a:t>نبدأ بسؤال أنفسنا فيما إذا كنا قمنا بصياغة سؤال قابل للحل، </a:t>
            </a:r>
          </a:p>
          <a:p>
            <a:pPr marL="0" indent="0" algn="just" rtl="1">
              <a:buNone/>
            </a:pPr>
            <a:r>
              <a:rPr lang="ar-SY" dirty="0"/>
              <a:t>إذا قمنا بإيجاد دليل جيد بسرعة، </a:t>
            </a:r>
          </a:p>
          <a:p>
            <a:pPr marL="0" indent="0" algn="just" rtl="1">
              <a:buNone/>
            </a:pPr>
            <a:r>
              <a:rPr lang="ar-SY" dirty="0"/>
              <a:t>وفيما إذا قمنا بتقييم الدليل بشكل فعال، </a:t>
            </a:r>
          </a:p>
          <a:p>
            <a:pPr algn="just" rtl="1"/>
            <a:r>
              <a:rPr lang="ar-SY" dirty="0"/>
              <a:t>وفيما إذا كنا نقوم بدمج العناصر الثلاثة بطريقة منطقية. </a:t>
            </a: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  <a:r>
              <a:rPr lang="ar-SY" dirty="0"/>
              <a:t> </a:t>
            </a:r>
          </a:p>
          <a:p>
            <a:pPr algn="just" rtl="1"/>
            <a:r>
              <a:rPr lang="ar-SY" dirty="0"/>
              <a:t>نقوم بتقويم فيما إذا كانت المقاربة برمتها </a:t>
            </a:r>
          </a:p>
          <a:p>
            <a:pPr marL="0" indent="0" algn="just" rtl="1">
              <a:buNone/>
            </a:pPr>
            <a:r>
              <a:rPr lang="ar-SY" dirty="0"/>
              <a:t>أدت إلى تأثير إيجابي على النتائج المهمة للمريض. </a:t>
            </a:r>
            <a:r>
              <a:rPr lang="en-US" sz="2000" dirty="0"/>
              <a:t>(</a:t>
            </a:r>
            <a:r>
              <a:rPr lang="en-US" sz="2000" dirty="0" err="1"/>
              <a:t>Karagiannis</a:t>
            </a:r>
            <a:r>
              <a:rPr lang="en-US" sz="2000" dirty="0"/>
              <a:t>, 2019)</a:t>
            </a:r>
            <a:r>
              <a:rPr lang="ar-SY" dirty="0"/>
              <a:t> </a:t>
            </a: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AAB7A6A-C53B-4AF8-9FB7-443F59FAAB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416" y="1690688"/>
            <a:ext cx="4079677" cy="2719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3113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</TotalTime>
  <Words>720</Words>
  <Application>Microsoft Office PowerPoint</Application>
  <PresentationFormat>Widescreen</PresentationFormat>
  <Paragraphs>87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Simplified Arabic</vt:lpstr>
      <vt:lpstr>Office Theme</vt:lpstr>
      <vt:lpstr>الطب المسند بالدليل في ظروف العمل السريري</vt:lpstr>
      <vt:lpstr>الأهداف التعليمية:</vt:lpstr>
      <vt:lpstr>مراحل الطب المسند بالدليل</vt:lpstr>
      <vt:lpstr>مراحل الطب المسند بالدليل</vt:lpstr>
      <vt:lpstr>مراحل الطب المسند بالدليل</vt:lpstr>
      <vt:lpstr>مراحل الطب المسند بالدليل</vt:lpstr>
      <vt:lpstr>مراحل الطب المسند بالدليل</vt:lpstr>
      <vt:lpstr>مراحل الطب المسند بالدليل</vt:lpstr>
      <vt:lpstr>مراحل الطب المسند بالدليل</vt:lpstr>
      <vt:lpstr>PowerPoint Presentation</vt:lpstr>
      <vt:lpstr>المراجع</vt:lpstr>
    </vt:vector>
  </TitlesOfParts>
  <Company>SA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طب المسند بالدليل في ظروف العمل السريري</dc:title>
  <dc:creator>Maher Fattouh</dc:creator>
  <cp:lastModifiedBy>Yazan Kenjrawi</cp:lastModifiedBy>
  <cp:revision>22</cp:revision>
  <dcterms:created xsi:type="dcterms:W3CDTF">2021-05-07T13:07:52Z</dcterms:created>
  <dcterms:modified xsi:type="dcterms:W3CDTF">2021-06-12T20:39:39Z</dcterms:modified>
</cp:coreProperties>
</file>